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82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C663D5-C642-669F-6AFF-FFEE744D51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429C0B-C4F3-7857-581B-4B33473E44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5362F3-AD51-0F4D-B87D-0BA4CC1E8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E11FB7-AC40-185D-5593-88B318C7D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8864E9-0A93-2ED8-BC5A-28A2F24B9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9739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9CAEBC-C029-C759-D63B-391498FEA2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0C4046-2ECD-BFEA-A2B3-48EF593BDC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BB5AB0-4055-EED9-C5AB-9BA4CBE9E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DABC76-F757-356E-F54D-F1022D6D6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1AC3DF-9337-A9D8-B43B-94586A2E6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4183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5E0643D-27B9-ADB3-A9F9-F3FE1F4749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5B4BFE-1EEC-6D47-6388-91E79D83EA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F449AC-A860-1C98-9FE3-8EDEEA692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1CA6B7-90F4-3337-72F0-CF8B2BDDF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FAC9EC-67FE-B7CB-EF18-D45D7D45B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4563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A088DE-C98A-7C84-E68A-5F9B5A05FB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FA4A9E-69BC-4AA7-CA8A-D170D1665B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D5EED5-8A4D-6E9E-600F-5D21EB8C4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995CA4-93DB-0682-FD3B-EEBDBD03E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D328AB-7EAC-CB2E-ACAA-37A499648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8602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15CB6C-475E-36CC-72D4-711C5EF6E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BE2BD9-5C28-9990-3539-713A226FD8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36D6D-483E-4A3B-A5E6-7D2707AEF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8E8731-9416-F33A-21C5-EC504FDF4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9D8E68-2AD3-8723-F96A-7304D3973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4968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B96635-0D35-2F99-D242-513E1918B5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B59937-1F66-0E78-571A-787D1E84C3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E81249-7CB9-2C3A-94CC-2F4B25C94D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7758C3-5BBB-E517-6527-756239E1D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D34EAD-FCD2-8F11-C9DE-C614054D4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D3B15D-BFF9-E034-A1A2-18AAEE041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793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E972AF-6BAF-B233-6C2C-98EF80787E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A2440B-43A7-1535-C7AA-20634DFB14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129C30-C756-510C-F1BE-B0974EF44E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7DBD58-F489-0986-E707-4535202174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7C6A47-EF3E-6A92-AC9B-0D0BF4FF2C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7738775-430D-4B8A-6002-7850FDD75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283C53-8FA0-53E2-2F61-029BD85B5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88CF1E4-B277-23D6-4294-C543392A9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9852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397225-935B-9D08-F04E-807AAAB5B4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0F40C0-21D6-7E03-CA9E-C9819E3E64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F81B5E-F27D-0203-2A8C-026EFA649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549DF8-7A39-A93D-4F8E-A4321D8B7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0603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C1F1249-1067-53D9-485F-58CBE1575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688627-0901-1FDE-5651-FA884529F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06A14E-2961-ACD0-FB29-C87A4EB28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817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F74A05-237C-79CD-8AC0-13D4908D87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6834CB-765C-E9D8-E2E1-C450A3FA41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0FB232-1ECD-F51E-D23D-427C176C2B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8FBE9D-0BDA-6DAE-B3D7-262FDB4AD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6A7726-7137-1A48-AE2C-EA734120D6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CF8EDA-635D-EFDC-DB75-4ADE543E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8059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F0897F-F116-EFAD-09F1-5B9906E47D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FEA8D4-1CBB-C84E-854F-A55CE6F5E4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2054F0-97EA-E029-FA2B-466E854B19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031753-FD45-AB52-8660-D2DCC4060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7A357D-9CD6-2863-6D25-A5FAC9369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51E647-3C7E-EB33-416E-A17EB84760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2958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2B2CF1-B718-1896-78B4-129F5C8798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569850-BF42-544E-96A5-31E927463B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968D3F-42FD-3758-EE3F-16D05E3D92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36708F-3255-47EC-BCBF-EBA272AD9254}" type="datetimeFigureOut">
              <a:rPr lang="en-GB" smtClean="0"/>
              <a:t>23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EB43A6-E401-285A-D713-A68C41502F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34F84A-5773-82EE-6012-4C1A0F304D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3AC314-FE32-44F7-8E1E-85717E5C32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649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9425ED9-EEB5-38F0-C3D6-069CFB11ED9E}"/>
              </a:ext>
            </a:extLst>
          </p:cNvPr>
          <p:cNvSpPr txBox="1"/>
          <p:nvPr/>
        </p:nvSpPr>
        <p:spPr>
          <a:xfrm>
            <a:off x="0" y="107004"/>
            <a:ext cx="2254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Calibri" panose="020F0502020204030204" pitchFamily="34" charset="0"/>
                <a:cs typeface="Calibri" panose="020F0502020204030204" pitchFamily="34" charset="0"/>
              </a:rPr>
              <a:t>HT29_biological replicate n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ECFBC2E-3251-F77F-B75C-1AB205DBF7C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59" y="739107"/>
            <a:ext cx="4792182" cy="2996314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EC9F78EF-0906-53D4-94C7-06A9B8100CEE}"/>
              </a:ext>
            </a:extLst>
          </p:cNvPr>
          <p:cNvSpPr/>
          <p:nvPr/>
        </p:nvSpPr>
        <p:spPr>
          <a:xfrm>
            <a:off x="729574" y="1731522"/>
            <a:ext cx="1673158" cy="2723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9261B68-73C7-3E34-DBBC-AA56DC7FF03A}"/>
              </a:ext>
            </a:extLst>
          </p:cNvPr>
          <p:cNvSpPr/>
          <p:nvPr/>
        </p:nvSpPr>
        <p:spPr>
          <a:xfrm>
            <a:off x="729574" y="2052438"/>
            <a:ext cx="1673158" cy="2723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F11156C-5200-2E84-2345-10065DEE4400}"/>
              </a:ext>
            </a:extLst>
          </p:cNvPr>
          <p:cNvSpPr txBox="1"/>
          <p:nvPr/>
        </p:nvSpPr>
        <p:spPr>
          <a:xfrm>
            <a:off x="2402732" y="1689614"/>
            <a:ext cx="5004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6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E07F721-1E51-7DA9-FAFD-EBAD7F1316E7}"/>
              </a:ext>
            </a:extLst>
          </p:cNvPr>
          <p:cNvSpPr txBox="1"/>
          <p:nvPr/>
        </p:nvSpPr>
        <p:spPr>
          <a:xfrm>
            <a:off x="2402732" y="1986259"/>
            <a:ext cx="7633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-actin</a:t>
            </a:r>
          </a:p>
        </p:txBody>
      </p:sp>
      <p:pic>
        <p:nvPicPr>
          <p:cNvPr id="14" name="Picture 13" descr="A white background with black spots&#10;&#10;Description automatically generated">
            <a:extLst>
              <a:ext uri="{FF2B5EF4-FFF2-40B4-BE49-F238E27FC236}">
                <a16:creationId xmlns:a16="http://schemas.microsoft.com/office/drawing/2014/main" id="{A9C87BC4-E498-C542-DC51-1711BDB2D8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8763" y="739107"/>
            <a:ext cx="6083808" cy="3267456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2E0DEBA8-47A6-C7CF-E96F-050A2DFD8EFE}"/>
              </a:ext>
            </a:extLst>
          </p:cNvPr>
          <p:cNvSpPr/>
          <p:nvPr/>
        </p:nvSpPr>
        <p:spPr>
          <a:xfrm>
            <a:off x="6096000" y="1175719"/>
            <a:ext cx="1770098" cy="338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D2D416A-E51D-0F0A-C00A-1C2984ADE68A}"/>
              </a:ext>
            </a:extLst>
          </p:cNvPr>
          <p:cNvSpPr txBox="1"/>
          <p:nvPr/>
        </p:nvSpPr>
        <p:spPr>
          <a:xfrm>
            <a:off x="8069964" y="1175718"/>
            <a:ext cx="6110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ERK</a:t>
            </a:r>
          </a:p>
        </p:txBody>
      </p:sp>
    </p:spTree>
    <p:extLst>
      <p:ext uri="{BB962C8B-B14F-4D97-AF65-F5344CB8AC3E}">
        <p14:creationId xmlns:p14="http://schemas.microsoft.com/office/powerpoint/2010/main" val="2324773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7987B40E-0499-19DB-920E-D60BB5D8BC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534" y="3935920"/>
            <a:ext cx="4696703" cy="2522478"/>
          </a:xfrm>
          <a:prstGeom prst="rect">
            <a:avLst/>
          </a:prstGeom>
        </p:spPr>
      </p:pic>
      <p:pic>
        <p:nvPicPr>
          <p:cNvPr id="3" name="Picture 2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28BCB1EE-628E-39D3-BBDB-C34FDBF9CFF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049" y="1067028"/>
            <a:ext cx="4696703" cy="252247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2139C40-CA0F-19B6-F281-15D5BF202441}"/>
              </a:ext>
            </a:extLst>
          </p:cNvPr>
          <p:cNvSpPr txBox="1"/>
          <p:nvPr/>
        </p:nvSpPr>
        <p:spPr>
          <a:xfrm>
            <a:off x="0" y="107004"/>
            <a:ext cx="2254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Calibri" panose="020F0502020204030204" pitchFamily="34" charset="0"/>
                <a:cs typeface="Calibri" panose="020F0502020204030204" pitchFamily="34" charset="0"/>
              </a:rPr>
              <a:t>HT29_biological replicate n2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4175CED-E666-60ED-5C6B-8BD5B1BBD3CC}"/>
              </a:ext>
            </a:extLst>
          </p:cNvPr>
          <p:cNvSpPr/>
          <p:nvPr/>
        </p:nvSpPr>
        <p:spPr>
          <a:xfrm>
            <a:off x="639783" y="2351927"/>
            <a:ext cx="1428988" cy="2596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EE92DA1-0084-A092-6166-C071785126AE}"/>
              </a:ext>
            </a:extLst>
          </p:cNvPr>
          <p:cNvSpPr txBox="1"/>
          <p:nvPr/>
        </p:nvSpPr>
        <p:spPr>
          <a:xfrm>
            <a:off x="2090523" y="2312467"/>
            <a:ext cx="5642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62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CD38640-DC9C-A377-0947-856ADCB827DE}"/>
              </a:ext>
            </a:extLst>
          </p:cNvPr>
          <p:cNvSpPr/>
          <p:nvPr/>
        </p:nvSpPr>
        <p:spPr>
          <a:xfrm>
            <a:off x="631321" y="5415282"/>
            <a:ext cx="1510083" cy="2265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09A36AA-69E4-03EA-D62D-49E2427EF9F4}"/>
              </a:ext>
            </a:extLst>
          </p:cNvPr>
          <p:cNvSpPr txBox="1"/>
          <p:nvPr/>
        </p:nvSpPr>
        <p:spPr>
          <a:xfrm>
            <a:off x="2141404" y="5359277"/>
            <a:ext cx="7633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-actin</a:t>
            </a:r>
          </a:p>
        </p:txBody>
      </p:sp>
      <p:pic>
        <p:nvPicPr>
          <p:cNvPr id="17" name="Picture 16" descr="A close-up of a dna&#10;&#10;Description automatically generated">
            <a:extLst>
              <a:ext uri="{FF2B5EF4-FFF2-40B4-BE49-F238E27FC236}">
                <a16:creationId xmlns:a16="http://schemas.microsoft.com/office/drawing/2014/main" id="{1B31DBFD-8E86-9A6F-2473-7B9B8E311DB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9888" y="1076755"/>
            <a:ext cx="4696703" cy="2522478"/>
          </a:xfrm>
          <a:prstGeom prst="rect">
            <a:avLst/>
          </a:prstGeo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8ADA338D-F24E-FC49-43FC-E09A812DDF76}"/>
              </a:ext>
            </a:extLst>
          </p:cNvPr>
          <p:cNvSpPr/>
          <p:nvPr/>
        </p:nvSpPr>
        <p:spPr>
          <a:xfrm>
            <a:off x="5575726" y="1820982"/>
            <a:ext cx="1428190" cy="2295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FB2AF25-0DD1-BE46-AF33-6F9973437B67}"/>
              </a:ext>
            </a:extLst>
          </p:cNvPr>
          <p:cNvSpPr txBox="1"/>
          <p:nvPr/>
        </p:nvSpPr>
        <p:spPr>
          <a:xfrm>
            <a:off x="7092706" y="1766482"/>
            <a:ext cx="6110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ERK</a:t>
            </a:r>
          </a:p>
        </p:txBody>
      </p:sp>
    </p:spTree>
    <p:extLst>
      <p:ext uri="{BB962C8B-B14F-4D97-AF65-F5344CB8AC3E}">
        <p14:creationId xmlns:p14="http://schemas.microsoft.com/office/powerpoint/2010/main" val="37449765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66B3FD9-CFDC-C236-CACF-760344E321D2}"/>
              </a:ext>
            </a:extLst>
          </p:cNvPr>
          <p:cNvSpPr txBox="1"/>
          <p:nvPr/>
        </p:nvSpPr>
        <p:spPr>
          <a:xfrm>
            <a:off x="0" y="107004"/>
            <a:ext cx="2254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Calibri" panose="020F0502020204030204" pitchFamily="34" charset="0"/>
                <a:cs typeface="Calibri" panose="020F0502020204030204" pitchFamily="34" charset="0"/>
              </a:rPr>
              <a:t>HT29_biological replicate n3</a:t>
            </a:r>
          </a:p>
        </p:txBody>
      </p:sp>
      <p:pic>
        <p:nvPicPr>
          <p:cNvPr id="8" name="Picture 7" descr="A close-up of a piece of paper&#10;&#10;Description automatically generated">
            <a:extLst>
              <a:ext uri="{FF2B5EF4-FFF2-40B4-BE49-F238E27FC236}">
                <a16:creationId xmlns:a16="http://schemas.microsoft.com/office/drawing/2014/main" id="{F4C219F7-60F0-56B4-D1AE-5E09C06607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23467" y="1417717"/>
            <a:ext cx="5090916" cy="3815636"/>
          </a:xfrm>
          <a:prstGeom prst="rect">
            <a:avLst/>
          </a:prstGeom>
        </p:spPr>
      </p:pic>
      <p:pic>
        <p:nvPicPr>
          <p:cNvPr id="10" name="Picture 9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0FF83471-E23D-536C-CB05-95E6C1FD223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044" y="1417717"/>
            <a:ext cx="5235585" cy="3273552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389916FC-B614-B324-5C19-49D2D0B7F0D2}"/>
              </a:ext>
            </a:extLst>
          </p:cNvPr>
          <p:cNvSpPr/>
          <p:nvPr/>
        </p:nvSpPr>
        <p:spPr>
          <a:xfrm>
            <a:off x="466927" y="2529190"/>
            <a:ext cx="1673158" cy="2723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6B4B168-3D5B-C085-D1A5-0E9B4E2FAED4}"/>
              </a:ext>
            </a:extLst>
          </p:cNvPr>
          <p:cNvSpPr/>
          <p:nvPr/>
        </p:nvSpPr>
        <p:spPr>
          <a:xfrm>
            <a:off x="466927" y="2850106"/>
            <a:ext cx="1673158" cy="2723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3F09CFC-B499-1327-D140-4FF99C02EACE}"/>
              </a:ext>
            </a:extLst>
          </p:cNvPr>
          <p:cNvSpPr txBox="1"/>
          <p:nvPr/>
        </p:nvSpPr>
        <p:spPr>
          <a:xfrm>
            <a:off x="2140085" y="2487282"/>
            <a:ext cx="5004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6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0DF8398-0838-E591-4803-60D279FECD90}"/>
              </a:ext>
            </a:extLst>
          </p:cNvPr>
          <p:cNvSpPr txBox="1"/>
          <p:nvPr/>
        </p:nvSpPr>
        <p:spPr>
          <a:xfrm>
            <a:off x="2140085" y="2783927"/>
            <a:ext cx="7633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-actin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FAEEEFA-85E2-B742-FAE9-4AE14EAB0283}"/>
              </a:ext>
            </a:extLst>
          </p:cNvPr>
          <p:cNvSpPr/>
          <p:nvPr/>
        </p:nvSpPr>
        <p:spPr>
          <a:xfrm>
            <a:off x="6362226" y="1808017"/>
            <a:ext cx="1770098" cy="338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D73FB51-D650-9F9C-7EA9-4E1D281EE143}"/>
              </a:ext>
            </a:extLst>
          </p:cNvPr>
          <p:cNvSpPr txBox="1"/>
          <p:nvPr/>
        </p:nvSpPr>
        <p:spPr>
          <a:xfrm>
            <a:off x="8336190" y="1808016"/>
            <a:ext cx="6110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ERK</a:t>
            </a:r>
          </a:p>
        </p:txBody>
      </p:sp>
    </p:spTree>
    <p:extLst>
      <p:ext uri="{BB962C8B-B14F-4D97-AF65-F5344CB8AC3E}">
        <p14:creationId xmlns:p14="http://schemas.microsoft.com/office/powerpoint/2010/main" val="3866868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</TotalTime>
  <Words>27</Words>
  <Application>Microsoft Office PowerPoint</Application>
  <PresentationFormat>Widescreen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la Estephan</dc:creator>
  <cp:lastModifiedBy>Hala Estephan</cp:lastModifiedBy>
  <cp:revision>9</cp:revision>
  <dcterms:created xsi:type="dcterms:W3CDTF">2024-08-22T10:52:09Z</dcterms:created>
  <dcterms:modified xsi:type="dcterms:W3CDTF">2024-08-23T16:39:23Z</dcterms:modified>
</cp:coreProperties>
</file>